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4"/>
  </p:notesMasterIdLst>
  <p:sldIdLst>
    <p:sldId id="256" r:id="rId2"/>
    <p:sldId id="261" r:id="rId3"/>
    <p:sldId id="260" r:id="rId4"/>
    <p:sldId id="259" r:id="rId5"/>
    <p:sldId id="257" r:id="rId6"/>
    <p:sldId id="262" r:id="rId7"/>
    <p:sldId id="263" r:id="rId8"/>
    <p:sldId id="264" r:id="rId9"/>
    <p:sldId id="258" r:id="rId10"/>
    <p:sldId id="265" r:id="rId11"/>
    <p:sldId id="266" r:id="rId12"/>
    <p:sldId id="267" r:id="rId1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427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90"/>
    <p:restoredTop sz="94752"/>
  </p:normalViewPr>
  <p:slideViewPr>
    <p:cSldViewPr snapToGrid="0" showGuides="1">
      <p:cViewPr varScale="1">
        <p:scale>
          <a:sx n="104" d="100"/>
          <a:sy n="104" d="100"/>
        </p:scale>
        <p:origin x="564" y="114"/>
      </p:cViewPr>
      <p:guideLst>
        <p:guide orient="horz" pos="2137"/>
        <p:guide pos="427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F78A99-FCE8-2E4E-BBF2-6953BFBEF934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1432D9-0748-764E-882D-7158E699AC8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916760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1432D9-0748-764E-882D-7158E699AC8E}" type="slidenum">
              <a:rPr kumimoji="1" lang="zh-CN" altLang="en-US" smtClean="0"/>
              <a:t>5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284519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1432D9-0748-764E-882D-7158E699AC8E}" type="slidenum">
              <a:rPr kumimoji="1" lang="zh-CN" altLang="en-US" smtClean="0"/>
              <a:t>6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74024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1432D9-0748-764E-882D-7158E699AC8E}" type="slidenum">
              <a:rPr kumimoji="1" lang="zh-CN" altLang="en-US" smtClean="0"/>
              <a:t>7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5646451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1432D9-0748-764E-882D-7158E699AC8E}" type="slidenum">
              <a:rPr kumimoji="1" lang="zh-CN" altLang="en-US" smtClean="0"/>
              <a:t>8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596356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D71FC0-B216-2B1A-58B8-01995EBE21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CCB4135-185C-3A0A-C03A-402CE1D873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8B135F-1B68-ACD6-B303-69115F64B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22228-D9BD-AB46-A1E6-9DB35F179E3D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8DF529-95D6-24F1-07A0-A170ABDC91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A12B2E4-5474-9020-CB45-DDA3B93EF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E113-3745-0445-84E4-BE15E7CBCBD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67631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2C7030-F5A8-B782-0731-A4FD5FE7E4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5DDB7B2-700A-F310-481C-A2B1A74158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C0BB6F-9558-C1C4-85FA-3EA57EA70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22228-D9BD-AB46-A1E6-9DB35F179E3D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A613A8-9629-0EA6-A780-762000E4AF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AC8B28-978B-97FA-A5E0-57A0136F7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E113-3745-0445-84E4-BE15E7CBCBD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80976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3D9B128-E5EC-59C4-9DA6-D41E1AC25E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2F94E99-BF8C-39C3-F6F1-68A1E73E58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345062-33BD-B540-ED2A-8D3512BB6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22228-D9BD-AB46-A1E6-9DB35F179E3D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C39DA9-8489-BF4F-9CB5-FB8CCA6B6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70541A-7241-51B8-7D9D-75DC09B1C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E113-3745-0445-84E4-BE15E7CBCBD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588196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72C1FE-1CC4-8E33-70D6-C4122B3368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1EBAD4-E57B-C9EB-CF58-BF3F2B45C5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589089-D729-F05A-73CC-7931B75C2A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22228-D9BD-AB46-A1E6-9DB35F179E3D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5B8DBC-B8EB-E19C-5A77-38A389696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EABADD-38B4-5372-EDBC-FF08B1DB55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E113-3745-0445-84E4-BE15E7CBCBD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340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E02B1D-294F-F61F-C30C-28F4B9D921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7847F34-4DDD-CAF0-71AE-229D08846D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070D07-4F9A-623D-F37B-69ECBF713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22228-D9BD-AB46-A1E6-9DB35F179E3D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FEC6BD-28D1-3FDA-7A65-7298596C5A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C0C1DA-DEDE-8EE9-E253-CBA1F1E8A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E113-3745-0445-84E4-BE15E7CBCBD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43294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FDA1D8-A5D6-A2CB-596D-B5D1D9109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862AC5F-2197-2062-9751-3142F9B2A6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B98D3BE-CBD3-CA83-B7C3-BF378EAF84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9A6CB7E-7433-1562-80B5-6FCFA8FE6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22228-D9BD-AB46-A1E6-9DB35F179E3D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B02CB09-ED9F-21C0-AD68-2ADEA40FA0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14B4AC6-CBF6-0F78-DA07-E3D041BB56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E113-3745-0445-84E4-BE15E7CBCBD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46649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44640F-9D8E-A129-BA96-DC11806252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3A5E2C9-E9FA-06E1-0F0B-C3DAA83904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960452-DB16-D22C-60D7-F973EF32A2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EB56285-F035-74C2-49B8-133DA32038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FC56727-97C7-A46A-00E4-A4892DCD74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52B979B-5BE9-F348-1D62-3EE462B483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22228-D9BD-AB46-A1E6-9DB35F179E3D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6056F41-61E6-B89F-5FBB-C8563D743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FAC6FE5-5D94-D764-9E5D-20982984D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E113-3745-0445-84E4-BE15E7CBCBD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91946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9C4E5D-4F8C-E3AF-11D2-93A5627D4E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AE62E3F-4BC3-9A9B-B9AB-852E7E162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22228-D9BD-AB46-A1E6-9DB35F179E3D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C50A9E2-BD67-24F9-E236-82832B8E8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7E6C7D2-660C-D867-4723-B5F3A93E8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E113-3745-0445-84E4-BE15E7CBCBD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77991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FC3FE73-96FE-57F2-E97A-383407A45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22228-D9BD-AB46-A1E6-9DB35F179E3D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D0872D5-0ED5-27B3-AEA3-392770292C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A8195A7-995A-6880-B070-B36AEC418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E113-3745-0445-84E4-BE15E7CBCBD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03183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23F1EB-706D-8B84-7FB9-87EA6A92F6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ECA284-C717-BDEB-78E3-71CD13235B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E94F242-029A-3E43-AE72-0620B39284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48B0BD5-E14A-65EB-6BA0-B00042C00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22228-D9BD-AB46-A1E6-9DB35F179E3D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550BCDF-5D57-1F06-CB77-BE618ED5AC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3B3BC49-02B9-2E1F-04DC-E1CA13C70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E113-3745-0445-84E4-BE15E7CBCBD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61792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D5693D-C707-FBC2-78C6-870411A7FF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8AEDEAD-CDB3-3456-00BE-79192CCA6D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780295E-3FDA-05FA-455C-28191FFA12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713F838-DEB6-3B89-3E8B-0FC936177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D22228-D9BD-AB46-A1E6-9DB35F179E3D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35038EB-204C-309E-AEFF-59F8E928A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5DC65A1-1E60-EDF3-A716-8B7BABA420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89E113-3745-0445-84E4-BE15E7CBCBD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361591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3447852-796E-DF06-D3D8-29071EA46C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5360A2F-3994-7FB5-B65B-77EBC1D18C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365ACC-BF46-5473-D126-6031D35561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3D22228-D9BD-AB46-A1E6-9DB35F179E3D}" type="datetimeFigureOut">
              <a:rPr kumimoji="1" lang="zh-CN" altLang="en-US" smtClean="0"/>
              <a:t>2024/3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DB232C-658B-350E-EF91-F469099727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2EA70D-A250-4ABE-6367-A257C89CC8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889E113-3745-0445-84E4-BE15E7CBCBD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20980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>
            <a:extLst>
              <a:ext uri="{FF2B5EF4-FFF2-40B4-BE49-F238E27FC236}">
                <a16:creationId xmlns:a16="http://schemas.microsoft.com/office/drawing/2014/main" id="{B442477F-92B2-B2DF-96E3-9BC113654E0A}"/>
              </a:ext>
            </a:extLst>
          </p:cNvPr>
          <p:cNvGrpSpPr/>
          <p:nvPr/>
        </p:nvGrpSpPr>
        <p:grpSpPr>
          <a:xfrm>
            <a:off x="566409" y="1278823"/>
            <a:ext cx="5437534" cy="3409200"/>
            <a:chOff x="681925" y="573437"/>
            <a:chExt cx="5437534" cy="3409200"/>
          </a:xfrm>
        </p:grpSpPr>
        <p:pic>
          <p:nvPicPr>
            <p:cNvPr id="4" name="Picture 3" descr="D:\201804东药\10.CEP对MP的协同作用P-gp GR通路（MOLT-4和MOLT-4 DNR）\WB\20190902 P-gp\20190903\0903-3 P-gp 4s prime.TIFF">
              <a:extLst>
                <a:ext uri="{FF2B5EF4-FFF2-40B4-BE49-F238E27FC236}">
                  <a16:creationId xmlns:a16="http://schemas.microsoft.com/office/drawing/2014/main" id="{A3A4BCFB-E919-BEAB-094B-313826401AD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36" t="-850" r="271" b="485"/>
            <a:stretch/>
          </p:blipFill>
          <p:spPr bwMode="auto">
            <a:xfrm>
              <a:off x="681925" y="573437"/>
              <a:ext cx="5284259" cy="3409200"/>
            </a:xfrm>
            <a:prstGeom prst="rect">
              <a:avLst/>
            </a:prstGeom>
            <a:noFill/>
            <a:ln w="1905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E7855726-7445-892C-D506-C1C2D4F59869}"/>
                </a:ext>
              </a:extLst>
            </p:cNvPr>
            <p:cNvSpPr txBox="1"/>
            <p:nvPr/>
          </p:nvSpPr>
          <p:spPr>
            <a:xfrm>
              <a:off x="1472339" y="1704814"/>
              <a:ext cx="2262753" cy="85240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kumimoji="1" lang="zh-CN" altLang="en-US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644EC76C-AF68-467C-EBEE-A178BD59B582}"/>
                </a:ext>
              </a:extLst>
            </p:cNvPr>
            <p:cNvSpPr txBox="1"/>
            <p:nvPr/>
          </p:nvSpPr>
          <p:spPr>
            <a:xfrm>
              <a:off x="1208867" y="2715930"/>
              <a:ext cx="36327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>
                  <a:solidFill>
                    <a:srgbClr val="FF0000"/>
                  </a:solidFill>
                </a:rPr>
                <a:t>This</a:t>
              </a:r>
              <a:r>
                <a:rPr kumimoji="1" lang="zh-CN" altLang="en-US" dirty="0">
                  <a:solidFill>
                    <a:srgbClr val="FF0000"/>
                  </a:solidFill>
                </a:rPr>
                <a:t> </a:t>
              </a:r>
              <a:r>
                <a:rPr kumimoji="1" lang="en-US" altLang="zh-CN" dirty="0">
                  <a:solidFill>
                    <a:srgbClr val="FF0000"/>
                  </a:solidFill>
                </a:rPr>
                <a:t>part was shown in manuscript.</a:t>
              </a:r>
              <a:endParaRPr kumimoji="1"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F2ED9E61-9B80-5338-4DA6-01269C0CADDA}"/>
                </a:ext>
              </a:extLst>
            </p:cNvPr>
            <p:cNvSpPr txBox="1"/>
            <p:nvPr/>
          </p:nvSpPr>
          <p:spPr>
            <a:xfrm>
              <a:off x="924173" y="1335482"/>
              <a:ext cx="569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CEP</a:t>
              </a:r>
              <a:endParaRPr kumimoji="1" lang="zh-CN" altLang="en-US" dirty="0"/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60C19A22-1DEF-E865-E109-496FD15D31D8}"/>
                </a:ext>
              </a:extLst>
            </p:cNvPr>
            <p:cNvSpPr txBox="1"/>
            <p:nvPr/>
          </p:nvSpPr>
          <p:spPr>
            <a:xfrm>
              <a:off x="1499283" y="1335482"/>
              <a:ext cx="46201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    0  0.03  0.3  1    3   0.03 0.3   1    3    (</a:t>
              </a:r>
              <a:r>
                <a:rPr kumimoji="1" lang="en-US" altLang="zh-CN" dirty="0" err="1"/>
                <a:t>μM</a:t>
              </a:r>
              <a:r>
                <a:rPr kumimoji="1" lang="en-US" altLang="zh-CN" dirty="0"/>
                <a:t>)  </a:t>
              </a:r>
              <a:endParaRPr kumimoji="1" lang="zh-CN" altLang="en-US" dirty="0"/>
            </a:p>
          </p:txBody>
        </p: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BBC2CB38-CB8C-BDD8-9FBC-387A4EAC2126}"/>
              </a:ext>
            </a:extLst>
          </p:cNvPr>
          <p:cNvGrpSpPr/>
          <p:nvPr/>
        </p:nvGrpSpPr>
        <p:grpSpPr>
          <a:xfrm>
            <a:off x="6641082" y="1131803"/>
            <a:ext cx="5404614" cy="3409200"/>
            <a:chOff x="6756598" y="573437"/>
            <a:chExt cx="5404614" cy="3409200"/>
          </a:xfrm>
        </p:grpSpPr>
        <p:pic>
          <p:nvPicPr>
            <p:cNvPr id="9" name="Picture 2" descr="D:\201804东药\10.CEP对MP的协同作用P-gp GR通路（MOLT-4和MOLT-4 DNR）\WB\20190902 P-gp\20190903\0903-3 b 8s prime.TIFF">
              <a:extLst>
                <a:ext uri="{FF2B5EF4-FFF2-40B4-BE49-F238E27FC236}">
                  <a16:creationId xmlns:a16="http://schemas.microsoft.com/office/drawing/2014/main" id="{D84D34D9-8873-879D-8370-65C5F3415C6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75" t="-2728" r="473" b="413"/>
            <a:stretch/>
          </p:blipFill>
          <p:spPr bwMode="auto">
            <a:xfrm>
              <a:off x="6756598" y="573437"/>
              <a:ext cx="5114440" cy="3409200"/>
            </a:xfrm>
            <a:prstGeom prst="rect">
              <a:avLst/>
            </a:prstGeom>
            <a:noFill/>
            <a:ln w="1905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4700D4A-2CDE-1245-B82E-EB741B039C82}"/>
                </a:ext>
              </a:extLst>
            </p:cNvPr>
            <p:cNvSpPr txBox="1"/>
            <p:nvPr/>
          </p:nvSpPr>
          <p:spPr>
            <a:xfrm>
              <a:off x="7541036" y="1778497"/>
              <a:ext cx="46201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    0  0.03  0.3  1    3   0.03 0.3   1    3    (</a:t>
              </a:r>
              <a:r>
                <a:rPr kumimoji="1" lang="en-US" altLang="zh-CN" dirty="0" err="1"/>
                <a:t>μM</a:t>
              </a:r>
              <a:r>
                <a:rPr kumimoji="1" lang="en-US" altLang="zh-CN" dirty="0"/>
                <a:t>)  </a:t>
              </a:r>
              <a:endParaRPr kumimoji="1" lang="zh-CN" altLang="en-US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CAB8BF90-9E72-EA24-035E-F230648F13A7}"/>
                </a:ext>
              </a:extLst>
            </p:cNvPr>
            <p:cNvSpPr txBox="1"/>
            <p:nvPr/>
          </p:nvSpPr>
          <p:spPr>
            <a:xfrm>
              <a:off x="7256342" y="1778497"/>
              <a:ext cx="569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/>
                <a:t>CEP</a:t>
              </a:r>
              <a:endParaRPr kumimoji="1" lang="zh-CN" altLang="en-US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F8E24311-4636-7035-8586-9346420B9ECF}"/>
                </a:ext>
              </a:extLst>
            </p:cNvPr>
            <p:cNvSpPr txBox="1"/>
            <p:nvPr/>
          </p:nvSpPr>
          <p:spPr>
            <a:xfrm>
              <a:off x="7588371" y="2131017"/>
              <a:ext cx="2262753" cy="85240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kumimoji="1" lang="zh-CN" altLang="en-US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DD5B490E-4F11-D126-9F42-F3827ED8F8FB}"/>
                </a:ext>
              </a:extLst>
            </p:cNvPr>
            <p:cNvSpPr txBox="1"/>
            <p:nvPr/>
          </p:nvSpPr>
          <p:spPr>
            <a:xfrm>
              <a:off x="7049145" y="3151277"/>
              <a:ext cx="36327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>
                  <a:solidFill>
                    <a:srgbClr val="FF0000"/>
                  </a:solidFill>
                </a:rPr>
                <a:t>This</a:t>
              </a:r>
              <a:r>
                <a:rPr kumimoji="1" lang="zh-CN" altLang="en-US" dirty="0">
                  <a:solidFill>
                    <a:srgbClr val="FF0000"/>
                  </a:solidFill>
                </a:rPr>
                <a:t> </a:t>
              </a:r>
              <a:r>
                <a:rPr kumimoji="1" lang="en-US" altLang="zh-CN" dirty="0">
                  <a:solidFill>
                    <a:srgbClr val="FF0000"/>
                  </a:solidFill>
                </a:rPr>
                <a:t>part was shown in manuscript.</a:t>
              </a:r>
              <a:endParaRPr kumimoji="1" lang="zh-CN" altLang="en-US" dirty="0">
                <a:solidFill>
                  <a:srgbClr val="FF0000"/>
                </a:solidFill>
              </a:endParaRPr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E0166D04-2CE4-D111-987B-3ABE12AF0615}"/>
              </a:ext>
            </a:extLst>
          </p:cNvPr>
          <p:cNvSpPr txBox="1"/>
          <p:nvPr/>
        </p:nvSpPr>
        <p:spPr>
          <a:xfrm>
            <a:off x="5088379" y="4943960"/>
            <a:ext cx="175560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Fig. 4C</a:t>
            </a:r>
            <a:endParaRPr kumimoji="1" lang="zh-CN" altLang="en-US" sz="40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FF0101A-150E-3767-4224-0B9B545BAF77}"/>
              </a:ext>
            </a:extLst>
          </p:cNvPr>
          <p:cNvSpPr txBox="1"/>
          <p:nvPr/>
        </p:nvSpPr>
        <p:spPr>
          <a:xfrm>
            <a:off x="1888305" y="768142"/>
            <a:ext cx="26404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P-glycoprotein</a:t>
            </a:r>
            <a:endParaRPr kumimoji="1" lang="zh-CN" altLang="en-US" sz="28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9B8F37F-D0D2-7E64-BB6F-00E04AC68FF4}"/>
              </a:ext>
            </a:extLst>
          </p:cNvPr>
          <p:cNvSpPr txBox="1"/>
          <p:nvPr/>
        </p:nvSpPr>
        <p:spPr>
          <a:xfrm>
            <a:off x="8604231" y="728846"/>
            <a:ext cx="13628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2800" b="1" dirty="0"/>
              <a:t>β</a:t>
            </a:r>
            <a:r>
              <a:rPr kumimoji="1" lang="en-US" altLang="zh-CN" sz="2800" b="1" dirty="0"/>
              <a:t>-actin</a:t>
            </a:r>
            <a:endParaRPr kumimoji="1"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E3A36339-925F-C178-F2B5-B0D26EEB12C6}"/>
              </a:ext>
            </a:extLst>
          </p:cNvPr>
          <p:cNvSpPr txBox="1"/>
          <p:nvPr/>
        </p:nvSpPr>
        <p:spPr>
          <a:xfrm>
            <a:off x="3236654" y="5625800"/>
            <a:ext cx="57038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Replicates performed-1</a:t>
            </a:r>
            <a:endParaRPr kumimoji="1"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28658588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图片 23" descr="图片包含 飞机, 空气, 游戏机, 男人&#10;&#10;描述已自动生成">
            <a:extLst>
              <a:ext uri="{FF2B5EF4-FFF2-40B4-BE49-F238E27FC236}">
                <a16:creationId xmlns:a16="http://schemas.microsoft.com/office/drawing/2014/main" id="{9981F188-6470-6914-739C-4EF56575EF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27784" y="1838095"/>
            <a:ext cx="5132346" cy="3421564"/>
          </a:xfrm>
          <a:prstGeom prst="rect">
            <a:avLst/>
          </a:prstGeom>
        </p:spPr>
      </p:pic>
      <p:pic>
        <p:nvPicPr>
          <p:cNvPr id="22" name="图片 21" descr="图片包含 游戏机, 飞机&#10;&#10;描述已自动生成">
            <a:extLst>
              <a:ext uri="{FF2B5EF4-FFF2-40B4-BE49-F238E27FC236}">
                <a16:creationId xmlns:a16="http://schemas.microsoft.com/office/drawing/2014/main" id="{BCDE2904-0540-109F-2B4A-935FA755E8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3185" y="1839031"/>
            <a:ext cx="5256349" cy="3504232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399D7FC-D591-3DCA-4DF0-01A86FBE2118}"/>
              </a:ext>
            </a:extLst>
          </p:cNvPr>
          <p:cNvSpPr txBox="1"/>
          <p:nvPr/>
        </p:nvSpPr>
        <p:spPr>
          <a:xfrm>
            <a:off x="1197786" y="2939768"/>
            <a:ext cx="47788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  0.03 0.1 0.3 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CBF7F53-E0EE-C3A8-78B9-545F5C4723E1}"/>
              </a:ext>
            </a:extLst>
          </p:cNvPr>
          <p:cNvSpPr txBox="1"/>
          <p:nvPr/>
        </p:nvSpPr>
        <p:spPr>
          <a:xfrm>
            <a:off x="865934" y="293976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37749A1-C82A-75A8-3536-95D5EB468246}"/>
              </a:ext>
            </a:extLst>
          </p:cNvPr>
          <p:cNvSpPr txBox="1"/>
          <p:nvPr/>
        </p:nvSpPr>
        <p:spPr>
          <a:xfrm>
            <a:off x="866598" y="2601432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B6B65D8-3BA9-2E3A-8772-D212317470F3}"/>
              </a:ext>
            </a:extLst>
          </p:cNvPr>
          <p:cNvSpPr txBox="1"/>
          <p:nvPr/>
        </p:nvSpPr>
        <p:spPr>
          <a:xfrm>
            <a:off x="1197786" y="2601432"/>
            <a:ext cx="52485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 +   +     +    +    +   +      (5 ng/mL) </a:t>
            </a:r>
            <a:endParaRPr kumimoji="1"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79F62E7-8E07-A224-B675-0FFDE79D1153}"/>
              </a:ext>
            </a:extLst>
          </p:cNvPr>
          <p:cNvSpPr txBox="1"/>
          <p:nvPr/>
        </p:nvSpPr>
        <p:spPr>
          <a:xfrm>
            <a:off x="5103662" y="5244308"/>
            <a:ext cx="174599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Fig. 5B</a:t>
            </a:r>
            <a:endParaRPr kumimoji="1" lang="zh-CN" altLang="en-US" sz="40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CD8C9D2-A298-AE35-5FD6-182BD920AD66}"/>
              </a:ext>
            </a:extLst>
          </p:cNvPr>
          <p:cNvSpPr txBox="1"/>
          <p:nvPr/>
        </p:nvSpPr>
        <p:spPr>
          <a:xfrm>
            <a:off x="2714694" y="1109215"/>
            <a:ext cx="6575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GR</a:t>
            </a:r>
            <a:endParaRPr kumimoji="1" lang="zh-CN" altLang="en-US" sz="2800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58FB3FA-B76C-1AFC-460B-6123BFEF1ECC}"/>
              </a:ext>
            </a:extLst>
          </p:cNvPr>
          <p:cNvSpPr txBox="1"/>
          <p:nvPr/>
        </p:nvSpPr>
        <p:spPr>
          <a:xfrm>
            <a:off x="7074696" y="2784670"/>
            <a:ext cx="4841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  0.03 0.1  0.3 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70979E3-C2AD-D809-1039-03D1686BAA0E}"/>
              </a:ext>
            </a:extLst>
          </p:cNvPr>
          <p:cNvSpPr txBox="1"/>
          <p:nvPr/>
        </p:nvSpPr>
        <p:spPr>
          <a:xfrm>
            <a:off x="6742844" y="2784670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9A0A83C-5525-728D-3A0E-D611DEE64AB9}"/>
              </a:ext>
            </a:extLst>
          </p:cNvPr>
          <p:cNvSpPr txBox="1"/>
          <p:nvPr/>
        </p:nvSpPr>
        <p:spPr>
          <a:xfrm>
            <a:off x="6743508" y="2446334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A6CB0C5-A9BF-0BD9-3D30-812D58598980}"/>
              </a:ext>
            </a:extLst>
          </p:cNvPr>
          <p:cNvSpPr txBox="1"/>
          <p:nvPr/>
        </p:nvSpPr>
        <p:spPr>
          <a:xfrm>
            <a:off x="7074696" y="2446334"/>
            <a:ext cx="5311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 +    +     +    +    +   +     (5 ng/mL)  </a:t>
            </a:r>
            <a:endParaRPr kumimoji="1"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F8BFCC0-CFEA-A5C9-E7C3-AB29DD3FBA44}"/>
              </a:ext>
            </a:extLst>
          </p:cNvPr>
          <p:cNvSpPr txBox="1"/>
          <p:nvPr/>
        </p:nvSpPr>
        <p:spPr>
          <a:xfrm>
            <a:off x="8370200" y="1081115"/>
            <a:ext cx="13628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2800" b="1" dirty="0"/>
              <a:t>β</a:t>
            </a:r>
            <a:r>
              <a:rPr kumimoji="1" lang="en-US" altLang="zh-CN" sz="2800" b="1" dirty="0"/>
              <a:t>-actin</a:t>
            </a:r>
            <a:endParaRPr kumimoji="1"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D85FBBE-C5F1-CDD8-AB85-3BBED778DD1C}"/>
              </a:ext>
            </a:extLst>
          </p:cNvPr>
          <p:cNvSpPr txBox="1"/>
          <p:nvPr/>
        </p:nvSpPr>
        <p:spPr>
          <a:xfrm>
            <a:off x="3170169" y="5847698"/>
            <a:ext cx="57038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Replicates performed-2</a:t>
            </a:r>
            <a:endParaRPr kumimoji="1"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224833013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 descr="图片包含 游戏机, 飞机, 男人, 火车&#10;&#10;描述已自动生成">
            <a:extLst>
              <a:ext uri="{FF2B5EF4-FFF2-40B4-BE49-F238E27FC236}">
                <a16:creationId xmlns:a16="http://schemas.microsoft.com/office/drawing/2014/main" id="{3DA60836-66EF-8532-CA22-7E281832B2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62628" y="2218369"/>
            <a:ext cx="4962774" cy="3104854"/>
          </a:xfrm>
          <a:prstGeom prst="rect">
            <a:avLst/>
          </a:prstGeom>
        </p:spPr>
      </p:pic>
      <p:pic>
        <p:nvPicPr>
          <p:cNvPr id="4" name="图片 3" descr="图片包含 飞机, 卡车, 男人, 跑道&#10;&#10;描述已自动生成">
            <a:extLst>
              <a:ext uri="{FF2B5EF4-FFF2-40B4-BE49-F238E27FC236}">
                <a16:creationId xmlns:a16="http://schemas.microsoft.com/office/drawing/2014/main" id="{01B5AD0E-A680-4E20-215F-AE5569432D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8648" y="2194581"/>
            <a:ext cx="5367352" cy="3104853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399D7FC-D591-3DCA-4DF0-01A86FBE2118}"/>
              </a:ext>
            </a:extLst>
          </p:cNvPr>
          <p:cNvSpPr txBox="1"/>
          <p:nvPr/>
        </p:nvSpPr>
        <p:spPr>
          <a:xfrm>
            <a:off x="1197786" y="2939768"/>
            <a:ext cx="47788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  0.03 0.1 0.3 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CBF7F53-E0EE-C3A8-78B9-545F5C4723E1}"/>
              </a:ext>
            </a:extLst>
          </p:cNvPr>
          <p:cNvSpPr txBox="1"/>
          <p:nvPr/>
        </p:nvSpPr>
        <p:spPr>
          <a:xfrm>
            <a:off x="865934" y="293976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37749A1-C82A-75A8-3536-95D5EB468246}"/>
              </a:ext>
            </a:extLst>
          </p:cNvPr>
          <p:cNvSpPr txBox="1"/>
          <p:nvPr/>
        </p:nvSpPr>
        <p:spPr>
          <a:xfrm>
            <a:off x="866598" y="2601432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B6B65D8-3BA9-2E3A-8772-D212317470F3}"/>
              </a:ext>
            </a:extLst>
          </p:cNvPr>
          <p:cNvSpPr txBox="1"/>
          <p:nvPr/>
        </p:nvSpPr>
        <p:spPr>
          <a:xfrm>
            <a:off x="1197786" y="2601432"/>
            <a:ext cx="52485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 +   +     +    +    +   +      (5 ng/mL) </a:t>
            </a:r>
            <a:endParaRPr kumimoji="1"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79F62E7-8E07-A224-B675-0FFDE79D1153}"/>
              </a:ext>
            </a:extLst>
          </p:cNvPr>
          <p:cNvSpPr txBox="1"/>
          <p:nvPr/>
        </p:nvSpPr>
        <p:spPr>
          <a:xfrm>
            <a:off x="5103662" y="5244308"/>
            <a:ext cx="174599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Fig. 5B</a:t>
            </a:r>
            <a:endParaRPr kumimoji="1" lang="zh-CN" altLang="en-US" sz="40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CD8C9D2-A298-AE35-5FD6-182BD920AD66}"/>
              </a:ext>
            </a:extLst>
          </p:cNvPr>
          <p:cNvSpPr txBox="1"/>
          <p:nvPr/>
        </p:nvSpPr>
        <p:spPr>
          <a:xfrm>
            <a:off x="2714694" y="1109215"/>
            <a:ext cx="6575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GR</a:t>
            </a:r>
            <a:endParaRPr kumimoji="1" lang="zh-CN" altLang="en-US" sz="2800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58FB3FA-B76C-1AFC-460B-6123BFEF1ECC}"/>
              </a:ext>
            </a:extLst>
          </p:cNvPr>
          <p:cNvSpPr txBox="1"/>
          <p:nvPr/>
        </p:nvSpPr>
        <p:spPr>
          <a:xfrm>
            <a:off x="6991568" y="3096396"/>
            <a:ext cx="4841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  0.03 0.1  0.3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70979E3-C2AD-D809-1039-03D1686BAA0E}"/>
              </a:ext>
            </a:extLst>
          </p:cNvPr>
          <p:cNvSpPr txBox="1"/>
          <p:nvPr/>
        </p:nvSpPr>
        <p:spPr>
          <a:xfrm>
            <a:off x="6659716" y="309639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9A0A83C-5525-728D-3A0E-D611DEE64AB9}"/>
              </a:ext>
            </a:extLst>
          </p:cNvPr>
          <p:cNvSpPr txBox="1"/>
          <p:nvPr/>
        </p:nvSpPr>
        <p:spPr>
          <a:xfrm>
            <a:off x="6660380" y="2758060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A6CB0C5-A9BF-0BD9-3D30-812D58598980}"/>
              </a:ext>
            </a:extLst>
          </p:cNvPr>
          <p:cNvSpPr txBox="1"/>
          <p:nvPr/>
        </p:nvSpPr>
        <p:spPr>
          <a:xfrm>
            <a:off x="6991568" y="2758060"/>
            <a:ext cx="5123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 +    +    +    +    +   +    (5 ng/mL) </a:t>
            </a:r>
            <a:endParaRPr kumimoji="1"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F8BFCC0-CFEA-A5C9-E7C3-AB29DD3FBA44}"/>
              </a:ext>
            </a:extLst>
          </p:cNvPr>
          <p:cNvSpPr txBox="1"/>
          <p:nvPr/>
        </p:nvSpPr>
        <p:spPr>
          <a:xfrm>
            <a:off x="8370200" y="1081115"/>
            <a:ext cx="13628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2800" b="1" dirty="0"/>
              <a:t>β</a:t>
            </a:r>
            <a:r>
              <a:rPr kumimoji="1" lang="en-US" altLang="zh-CN" sz="2800" b="1" dirty="0"/>
              <a:t>-actin</a:t>
            </a:r>
            <a:endParaRPr kumimoji="1"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D85FBBE-C5F1-CDD8-AB85-3BBED778DD1C}"/>
              </a:ext>
            </a:extLst>
          </p:cNvPr>
          <p:cNvSpPr txBox="1"/>
          <p:nvPr/>
        </p:nvSpPr>
        <p:spPr>
          <a:xfrm>
            <a:off x="3170169" y="5847698"/>
            <a:ext cx="57038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Replicates performed-3</a:t>
            </a:r>
            <a:endParaRPr kumimoji="1"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25737641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 descr="图片包含 游戏机, 飞机, 衬衫, 男人&#10;&#10;描述已自动生成">
            <a:extLst>
              <a:ext uri="{FF2B5EF4-FFF2-40B4-BE49-F238E27FC236}">
                <a16:creationId xmlns:a16="http://schemas.microsoft.com/office/drawing/2014/main" id="{155D758B-E09A-070B-FCD5-E7838CDC79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53507" y="2009915"/>
            <a:ext cx="5311069" cy="3228937"/>
          </a:xfrm>
          <a:prstGeom prst="rect">
            <a:avLst/>
          </a:prstGeom>
        </p:spPr>
      </p:pic>
      <p:pic>
        <p:nvPicPr>
          <p:cNvPr id="4" name="图片 3" descr="图片包含 游戏机, 飞机, 船&#10;&#10;描述已自动生成">
            <a:extLst>
              <a:ext uri="{FF2B5EF4-FFF2-40B4-BE49-F238E27FC236}">
                <a16:creationId xmlns:a16="http://schemas.microsoft.com/office/drawing/2014/main" id="{71332B15-7B60-8A20-1048-BFF0BF3EAF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1857" y="1953846"/>
            <a:ext cx="5235116" cy="3227594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399D7FC-D591-3DCA-4DF0-01A86FBE2118}"/>
              </a:ext>
            </a:extLst>
          </p:cNvPr>
          <p:cNvSpPr txBox="1"/>
          <p:nvPr/>
        </p:nvSpPr>
        <p:spPr>
          <a:xfrm>
            <a:off x="1197786" y="2939768"/>
            <a:ext cx="47788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  0.03 0.1 0.3 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CBF7F53-E0EE-C3A8-78B9-545F5C4723E1}"/>
              </a:ext>
            </a:extLst>
          </p:cNvPr>
          <p:cNvSpPr txBox="1"/>
          <p:nvPr/>
        </p:nvSpPr>
        <p:spPr>
          <a:xfrm>
            <a:off x="865934" y="293976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37749A1-C82A-75A8-3536-95D5EB468246}"/>
              </a:ext>
            </a:extLst>
          </p:cNvPr>
          <p:cNvSpPr txBox="1"/>
          <p:nvPr/>
        </p:nvSpPr>
        <p:spPr>
          <a:xfrm>
            <a:off x="866598" y="2601432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B6B65D8-3BA9-2E3A-8772-D212317470F3}"/>
              </a:ext>
            </a:extLst>
          </p:cNvPr>
          <p:cNvSpPr txBox="1"/>
          <p:nvPr/>
        </p:nvSpPr>
        <p:spPr>
          <a:xfrm>
            <a:off x="1197786" y="2601432"/>
            <a:ext cx="52485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 +   +     +    +    +   +      (5 ng/mL) </a:t>
            </a:r>
            <a:endParaRPr kumimoji="1"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79F62E7-8E07-A224-B675-0FFDE79D1153}"/>
              </a:ext>
            </a:extLst>
          </p:cNvPr>
          <p:cNvSpPr txBox="1"/>
          <p:nvPr/>
        </p:nvSpPr>
        <p:spPr>
          <a:xfrm>
            <a:off x="5103662" y="5244308"/>
            <a:ext cx="174599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Fig. 5B</a:t>
            </a:r>
            <a:endParaRPr kumimoji="1" lang="zh-CN" altLang="en-US" sz="40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CD8C9D2-A298-AE35-5FD6-182BD920AD66}"/>
              </a:ext>
            </a:extLst>
          </p:cNvPr>
          <p:cNvSpPr txBox="1"/>
          <p:nvPr/>
        </p:nvSpPr>
        <p:spPr>
          <a:xfrm>
            <a:off x="2714694" y="1109215"/>
            <a:ext cx="6575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GR</a:t>
            </a:r>
            <a:endParaRPr kumimoji="1" lang="zh-CN" altLang="en-US" sz="2800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58FB3FA-B76C-1AFC-460B-6123BFEF1ECC}"/>
              </a:ext>
            </a:extLst>
          </p:cNvPr>
          <p:cNvSpPr txBox="1"/>
          <p:nvPr/>
        </p:nvSpPr>
        <p:spPr>
          <a:xfrm>
            <a:off x="6991568" y="2722326"/>
            <a:ext cx="4841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  0.03 0.1  0.3 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70979E3-C2AD-D809-1039-03D1686BAA0E}"/>
              </a:ext>
            </a:extLst>
          </p:cNvPr>
          <p:cNvSpPr txBox="1"/>
          <p:nvPr/>
        </p:nvSpPr>
        <p:spPr>
          <a:xfrm>
            <a:off x="6659716" y="272232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9A0A83C-5525-728D-3A0E-D611DEE64AB9}"/>
              </a:ext>
            </a:extLst>
          </p:cNvPr>
          <p:cNvSpPr txBox="1"/>
          <p:nvPr/>
        </p:nvSpPr>
        <p:spPr>
          <a:xfrm>
            <a:off x="6660380" y="2383990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A6CB0C5-A9BF-0BD9-3D30-812D58598980}"/>
              </a:ext>
            </a:extLst>
          </p:cNvPr>
          <p:cNvSpPr txBox="1"/>
          <p:nvPr/>
        </p:nvSpPr>
        <p:spPr>
          <a:xfrm>
            <a:off x="6991568" y="2383990"/>
            <a:ext cx="5311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 +    +     +    +    +   +     (5 ng/mL)  </a:t>
            </a:r>
            <a:endParaRPr kumimoji="1"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F8BFCC0-CFEA-A5C9-E7C3-AB29DD3FBA44}"/>
              </a:ext>
            </a:extLst>
          </p:cNvPr>
          <p:cNvSpPr txBox="1"/>
          <p:nvPr/>
        </p:nvSpPr>
        <p:spPr>
          <a:xfrm>
            <a:off x="8370200" y="1081115"/>
            <a:ext cx="13628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2800" b="1" dirty="0"/>
              <a:t>β</a:t>
            </a:r>
            <a:r>
              <a:rPr kumimoji="1" lang="en-US" altLang="zh-CN" sz="2800" b="1" dirty="0"/>
              <a:t>-actin</a:t>
            </a:r>
            <a:endParaRPr kumimoji="1"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D85FBBE-C5F1-CDD8-AB85-3BBED778DD1C}"/>
              </a:ext>
            </a:extLst>
          </p:cNvPr>
          <p:cNvSpPr txBox="1"/>
          <p:nvPr/>
        </p:nvSpPr>
        <p:spPr>
          <a:xfrm>
            <a:off x="3170169" y="5847698"/>
            <a:ext cx="57038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Replicates performed-4</a:t>
            </a:r>
            <a:endParaRPr kumimoji="1"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20404451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图片包含 游戏机, 飞机, 衬衫, 男人&#10;&#10;描述已自动生成">
            <a:extLst>
              <a:ext uri="{FF2B5EF4-FFF2-40B4-BE49-F238E27FC236}">
                <a16:creationId xmlns:a16="http://schemas.microsoft.com/office/drawing/2014/main" id="{870D0B6C-9F8B-86E1-90E9-E4CC2B00C9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72370" y="1309172"/>
            <a:ext cx="5306288" cy="2800298"/>
          </a:xfrm>
          <a:prstGeom prst="rect">
            <a:avLst/>
          </a:prstGeom>
        </p:spPr>
      </p:pic>
      <p:pic>
        <p:nvPicPr>
          <p:cNvPr id="4" name="图片 3" descr="图片包含 形状&#10;&#10;描述已自动生成">
            <a:extLst>
              <a:ext uri="{FF2B5EF4-FFF2-40B4-BE49-F238E27FC236}">
                <a16:creationId xmlns:a16="http://schemas.microsoft.com/office/drawing/2014/main" id="{FBD17CDA-281D-E994-C0A4-D3849CA25C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072" y="1347610"/>
            <a:ext cx="5306291" cy="2800298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2ED9E61-9B80-5338-4DA6-01269C0CADDA}"/>
              </a:ext>
            </a:extLst>
          </p:cNvPr>
          <p:cNvSpPr txBox="1"/>
          <p:nvPr/>
        </p:nvSpPr>
        <p:spPr>
          <a:xfrm>
            <a:off x="808657" y="204086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0C19A22-1DEF-E865-E109-496FD15D31D8}"/>
              </a:ext>
            </a:extLst>
          </p:cNvPr>
          <p:cNvSpPr txBox="1"/>
          <p:nvPr/>
        </p:nvSpPr>
        <p:spPr>
          <a:xfrm>
            <a:off x="1383767" y="2040868"/>
            <a:ext cx="4620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0.03  0.3  1    3   0.03 0.3   1    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4700D4A-2CDE-1245-B82E-EB741B039C82}"/>
              </a:ext>
            </a:extLst>
          </p:cNvPr>
          <p:cNvSpPr txBox="1"/>
          <p:nvPr/>
        </p:nvSpPr>
        <p:spPr>
          <a:xfrm>
            <a:off x="7425520" y="2336863"/>
            <a:ext cx="4620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0.03  0.3  1    3   0.03 0.3   1    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AB8BF90-9E72-EA24-035E-F230648F13A7}"/>
              </a:ext>
            </a:extLst>
          </p:cNvPr>
          <p:cNvSpPr txBox="1"/>
          <p:nvPr/>
        </p:nvSpPr>
        <p:spPr>
          <a:xfrm>
            <a:off x="7140826" y="233686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0166D04-2CE4-D111-987B-3ABE12AF0615}"/>
              </a:ext>
            </a:extLst>
          </p:cNvPr>
          <p:cNvSpPr txBox="1"/>
          <p:nvPr/>
        </p:nvSpPr>
        <p:spPr>
          <a:xfrm>
            <a:off x="5088379" y="4943960"/>
            <a:ext cx="175560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Fig. 4C</a:t>
            </a:r>
            <a:endParaRPr kumimoji="1" lang="zh-CN" altLang="en-US" sz="40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FF0101A-150E-3767-4224-0B9B545BAF77}"/>
              </a:ext>
            </a:extLst>
          </p:cNvPr>
          <p:cNvSpPr txBox="1"/>
          <p:nvPr/>
        </p:nvSpPr>
        <p:spPr>
          <a:xfrm>
            <a:off x="1888305" y="768142"/>
            <a:ext cx="26404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P-glycoprotein</a:t>
            </a:r>
            <a:endParaRPr kumimoji="1" lang="zh-CN" altLang="en-US" sz="28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9B8F37F-D0D2-7E64-BB6F-00E04AC68FF4}"/>
              </a:ext>
            </a:extLst>
          </p:cNvPr>
          <p:cNvSpPr txBox="1"/>
          <p:nvPr/>
        </p:nvSpPr>
        <p:spPr>
          <a:xfrm>
            <a:off x="8604231" y="728846"/>
            <a:ext cx="13628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2800" b="1" dirty="0"/>
              <a:t>β</a:t>
            </a:r>
            <a:r>
              <a:rPr kumimoji="1" lang="en-US" altLang="zh-CN" sz="2800" b="1" dirty="0"/>
              <a:t>-actin</a:t>
            </a:r>
            <a:endParaRPr kumimoji="1"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6E2ADE4-AFEB-7613-800C-2312DC101E32}"/>
              </a:ext>
            </a:extLst>
          </p:cNvPr>
          <p:cNvSpPr txBox="1"/>
          <p:nvPr/>
        </p:nvSpPr>
        <p:spPr>
          <a:xfrm>
            <a:off x="3236654" y="5625800"/>
            <a:ext cx="57038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Replicates performed-2</a:t>
            </a:r>
            <a:endParaRPr kumimoji="1"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5042856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在地上&#10;&#10;中度可信度描述已自动生成">
            <a:extLst>
              <a:ext uri="{FF2B5EF4-FFF2-40B4-BE49-F238E27FC236}">
                <a16:creationId xmlns:a16="http://schemas.microsoft.com/office/drawing/2014/main" id="{9E6A0B03-DED1-C5BD-3DAD-A7CAD87467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74422" y="1375724"/>
            <a:ext cx="5012778" cy="3227316"/>
          </a:xfrm>
          <a:prstGeom prst="rect">
            <a:avLst/>
          </a:prstGeom>
        </p:spPr>
      </p:pic>
      <p:pic>
        <p:nvPicPr>
          <p:cNvPr id="4" name="图片 3" descr="图片包含 游戏机, 飞机&#10;&#10;描述已自动生成">
            <a:extLst>
              <a:ext uri="{FF2B5EF4-FFF2-40B4-BE49-F238E27FC236}">
                <a16:creationId xmlns:a16="http://schemas.microsoft.com/office/drawing/2014/main" id="{8BCFABC9-533C-3FBE-25A8-E6BA7D5E70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2678" y="1375724"/>
            <a:ext cx="5164667" cy="3227316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2ED9E61-9B80-5338-4DA6-01269C0CADDA}"/>
              </a:ext>
            </a:extLst>
          </p:cNvPr>
          <p:cNvSpPr txBox="1"/>
          <p:nvPr/>
        </p:nvSpPr>
        <p:spPr>
          <a:xfrm>
            <a:off x="808657" y="204086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0C19A22-1DEF-E865-E109-496FD15D31D8}"/>
              </a:ext>
            </a:extLst>
          </p:cNvPr>
          <p:cNvSpPr txBox="1"/>
          <p:nvPr/>
        </p:nvSpPr>
        <p:spPr>
          <a:xfrm>
            <a:off x="1383767" y="2040868"/>
            <a:ext cx="4620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0.03  0.3  1    3   0.03 0.3   1    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4700D4A-2CDE-1245-B82E-EB741B039C82}"/>
              </a:ext>
            </a:extLst>
          </p:cNvPr>
          <p:cNvSpPr txBox="1"/>
          <p:nvPr/>
        </p:nvSpPr>
        <p:spPr>
          <a:xfrm>
            <a:off x="7425520" y="2336863"/>
            <a:ext cx="4620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0.03  0.3  1    3   0.03 0.3   1    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AB8BF90-9E72-EA24-035E-F230648F13A7}"/>
              </a:ext>
            </a:extLst>
          </p:cNvPr>
          <p:cNvSpPr txBox="1"/>
          <p:nvPr/>
        </p:nvSpPr>
        <p:spPr>
          <a:xfrm>
            <a:off x="7140826" y="233686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0166D04-2CE4-D111-987B-3ABE12AF0615}"/>
              </a:ext>
            </a:extLst>
          </p:cNvPr>
          <p:cNvSpPr txBox="1"/>
          <p:nvPr/>
        </p:nvSpPr>
        <p:spPr>
          <a:xfrm>
            <a:off x="5088379" y="4943960"/>
            <a:ext cx="175560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Fig. 4C</a:t>
            </a:r>
            <a:endParaRPr kumimoji="1" lang="zh-CN" altLang="en-US" sz="40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FF0101A-150E-3767-4224-0B9B545BAF77}"/>
              </a:ext>
            </a:extLst>
          </p:cNvPr>
          <p:cNvSpPr txBox="1"/>
          <p:nvPr/>
        </p:nvSpPr>
        <p:spPr>
          <a:xfrm>
            <a:off x="1888305" y="768142"/>
            <a:ext cx="26404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P-glycoprotein</a:t>
            </a:r>
            <a:endParaRPr kumimoji="1" lang="zh-CN" altLang="en-US" sz="28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9B8F37F-D0D2-7E64-BB6F-00E04AC68FF4}"/>
              </a:ext>
            </a:extLst>
          </p:cNvPr>
          <p:cNvSpPr txBox="1"/>
          <p:nvPr/>
        </p:nvSpPr>
        <p:spPr>
          <a:xfrm>
            <a:off x="8604231" y="728846"/>
            <a:ext cx="13628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2800" b="1" dirty="0"/>
              <a:t>β</a:t>
            </a:r>
            <a:r>
              <a:rPr kumimoji="1" lang="en-US" altLang="zh-CN" sz="2800" b="1" dirty="0"/>
              <a:t>-actin</a:t>
            </a:r>
            <a:endParaRPr kumimoji="1"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6E2ADE4-AFEB-7613-800C-2312DC101E32}"/>
              </a:ext>
            </a:extLst>
          </p:cNvPr>
          <p:cNvSpPr txBox="1"/>
          <p:nvPr/>
        </p:nvSpPr>
        <p:spPr>
          <a:xfrm>
            <a:off x="3236654" y="5625800"/>
            <a:ext cx="57038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Replicates performed-3</a:t>
            </a:r>
            <a:endParaRPr kumimoji="1"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19317554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 descr="手机屏幕截图&#10;&#10;低可信度描述已自动生成">
            <a:extLst>
              <a:ext uri="{FF2B5EF4-FFF2-40B4-BE49-F238E27FC236}">
                <a16:creationId xmlns:a16="http://schemas.microsoft.com/office/drawing/2014/main" id="{1CC81B36-503B-EB45-987E-540BFAFDDF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24894" y="1478564"/>
            <a:ext cx="5181949" cy="2574645"/>
          </a:xfrm>
          <a:prstGeom prst="rect">
            <a:avLst/>
          </a:prstGeom>
        </p:spPr>
      </p:pic>
      <p:pic>
        <p:nvPicPr>
          <p:cNvPr id="19" name="图片 18" descr="手机屏幕的截图&#10;&#10;低可信度描述已自动生成">
            <a:extLst>
              <a:ext uri="{FF2B5EF4-FFF2-40B4-BE49-F238E27FC236}">
                <a16:creationId xmlns:a16="http://schemas.microsoft.com/office/drawing/2014/main" id="{96F49ECE-DD9A-3C46-7A8C-D99842BD26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2816" y="1448395"/>
            <a:ext cx="5213109" cy="257464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2ED9E61-9B80-5338-4DA6-01269C0CADDA}"/>
              </a:ext>
            </a:extLst>
          </p:cNvPr>
          <p:cNvSpPr txBox="1"/>
          <p:nvPr/>
        </p:nvSpPr>
        <p:spPr>
          <a:xfrm>
            <a:off x="808657" y="235259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0C19A22-1DEF-E865-E109-496FD15D31D8}"/>
              </a:ext>
            </a:extLst>
          </p:cNvPr>
          <p:cNvSpPr txBox="1"/>
          <p:nvPr/>
        </p:nvSpPr>
        <p:spPr>
          <a:xfrm>
            <a:off x="1383767" y="2331814"/>
            <a:ext cx="4620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0.03  0.3  1    3   0.03 0.3   1    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4700D4A-2CDE-1245-B82E-EB741B039C82}"/>
              </a:ext>
            </a:extLst>
          </p:cNvPr>
          <p:cNvSpPr txBox="1"/>
          <p:nvPr/>
        </p:nvSpPr>
        <p:spPr>
          <a:xfrm>
            <a:off x="7425520" y="2336863"/>
            <a:ext cx="4620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0.03  0.3  1    3   0.03 0.3   1    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AB8BF90-9E72-EA24-035E-F230648F13A7}"/>
              </a:ext>
            </a:extLst>
          </p:cNvPr>
          <p:cNvSpPr txBox="1"/>
          <p:nvPr/>
        </p:nvSpPr>
        <p:spPr>
          <a:xfrm>
            <a:off x="7140826" y="233686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0166D04-2CE4-D111-987B-3ABE12AF0615}"/>
              </a:ext>
            </a:extLst>
          </p:cNvPr>
          <p:cNvSpPr txBox="1"/>
          <p:nvPr/>
        </p:nvSpPr>
        <p:spPr>
          <a:xfrm>
            <a:off x="5088379" y="4943960"/>
            <a:ext cx="175560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Fig. 4C</a:t>
            </a:r>
            <a:endParaRPr kumimoji="1" lang="zh-CN" altLang="en-US" sz="40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FF0101A-150E-3767-4224-0B9B545BAF77}"/>
              </a:ext>
            </a:extLst>
          </p:cNvPr>
          <p:cNvSpPr txBox="1"/>
          <p:nvPr/>
        </p:nvSpPr>
        <p:spPr>
          <a:xfrm>
            <a:off x="1888305" y="768142"/>
            <a:ext cx="26404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P-glycoprotein</a:t>
            </a:r>
            <a:endParaRPr kumimoji="1" lang="zh-CN" altLang="en-US" sz="28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9B8F37F-D0D2-7E64-BB6F-00E04AC68FF4}"/>
              </a:ext>
            </a:extLst>
          </p:cNvPr>
          <p:cNvSpPr txBox="1"/>
          <p:nvPr/>
        </p:nvSpPr>
        <p:spPr>
          <a:xfrm>
            <a:off x="8604231" y="728846"/>
            <a:ext cx="13628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2800" b="1" dirty="0"/>
              <a:t>β</a:t>
            </a:r>
            <a:r>
              <a:rPr kumimoji="1" lang="en-US" altLang="zh-CN" sz="2800" b="1" dirty="0"/>
              <a:t>-actin</a:t>
            </a:r>
            <a:endParaRPr kumimoji="1"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6E2ADE4-AFEB-7613-800C-2312DC101E32}"/>
              </a:ext>
            </a:extLst>
          </p:cNvPr>
          <p:cNvSpPr txBox="1"/>
          <p:nvPr/>
        </p:nvSpPr>
        <p:spPr>
          <a:xfrm>
            <a:off x="3236654" y="5625800"/>
            <a:ext cx="57038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Replicates performed-4</a:t>
            </a:r>
            <a:endParaRPr kumimoji="1"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4885264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4" name="Picture 3" descr="E:\WB\20200109\20200109_2GR 8s prime.TIFF">
            <a:extLst>
              <a:ext uri="{FF2B5EF4-FFF2-40B4-BE49-F238E27FC236}">
                <a16:creationId xmlns:a16="http://schemas.microsoft.com/office/drawing/2014/main" id="{2CC00910-934E-A681-B316-04AB7658643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746"/>
          <a:stretch/>
        </p:blipFill>
        <p:spPr bwMode="auto">
          <a:xfrm>
            <a:off x="722036" y="1683800"/>
            <a:ext cx="5089829" cy="28624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8C82C04-7C8B-1ACC-36F7-4DD091E79644}"/>
              </a:ext>
            </a:extLst>
          </p:cNvPr>
          <p:cNvSpPr txBox="1"/>
          <p:nvPr/>
        </p:nvSpPr>
        <p:spPr>
          <a:xfrm>
            <a:off x="1213284" y="2350833"/>
            <a:ext cx="4653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0.03  0.1 0.3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67DFC13-7A07-AC62-030B-57B4263E5A04}"/>
              </a:ext>
            </a:extLst>
          </p:cNvPr>
          <p:cNvSpPr txBox="1"/>
          <p:nvPr/>
        </p:nvSpPr>
        <p:spPr>
          <a:xfrm>
            <a:off x="881432" y="235083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B531A10-4180-9A30-8DD0-79927A784CB7}"/>
              </a:ext>
            </a:extLst>
          </p:cNvPr>
          <p:cNvSpPr txBox="1"/>
          <p:nvPr/>
        </p:nvSpPr>
        <p:spPr>
          <a:xfrm>
            <a:off x="882096" y="2012497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EBF7D1F-5938-2DCD-99BE-A47C7BE6960A}"/>
              </a:ext>
            </a:extLst>
          </p:cNvPr>
          <p:cNvSpPr txBox="1"/>
          <p:nvPr/>
        </p:nvSpPr>
        <p:spPr>
          <a:xfrm>
            <a:off x="1213284" y="2012497"/>
            <a:ext cx="5174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+   +     +   +    +   +.     (5 ng/mL)  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C92382D-0C9F-1526-8673-F6E739AB00ED}"/>
              </a:ext>
            </a:extLst>
          </p:cNvPr>
          <p:cNvSpPr txBox="1"/>
          <p:nvPr/>
        </p:nvSpPr>
        <p:spPr>
          <a:xfrm>
            <a:off x="1137935" y="2685274"/>
            <a:ext cx="2262753" cy="540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58E53EB-BF88-19AD-D179-CE68D46F08FB}"/>
              </a:ext>
            </a:extLst>
          </p:cNvPr>
          <p:cNvSpPr txBox="1"/>
          <p:nvPr/>
        </p:nvSpPr>
        <p:spPr>
          <a:xfrm>
            <a:off x="1093351" y="3421316"/>
            <a:ext cx="3632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rgbClr val="FF0000"/>
                </a:solidFill>
              </a:rPr>
              <a:t>This</a:t>
            </a:r>
            <a:r>
              <a:rPr kumimoji="1" lang="zh-CN" altLang="en-US" dirty="0">
                <a:solidFill>
                  <a:srgbClr val="FF0000"/>
                </a:solidFill>
              </a:rPr>
              <a:t> </a:t>
            </a:r>
            <a:r>
              <a:rPr kumimoji="1" lang="en-US" altLang="zh-CN" dirty="0">
                <a:solidFill>
                  <a:srgbClr val="FF0000"/>
                </a:solidFill>
              </a:rPr>
              <a:t>part was shown in manuscript.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pic>
        <p:nvPicPr>
          <p:cNvPr id="12" name="Picture 4" descr="E:\WB\20200109\20200109_2TBP 4s prime.TIFF">
            <a:extLst>
              <a:ext uri="{FF2B5EF4-FFF2-40B4-BE49-F238E27FC236}">
                <a16:creationId xmlns:a16="http://schemas.microsoft.com/office/drawing/2014/main" id="{534F4632-85BD-40D1-CC10-D89AE359244A}"/>
              </a:ext>
            </a:extLst>
          </p:cNvPr>
          <p:cNvPicPr>
            <a:picLocks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" t="801" r="300" b="125"/>
          <a:stretch/>
        </p:blipFill>
        <p:spPr bwMode="auto">
          <a:xfrm>
            <a:off x="6324880" y="1748849"/>
            <a:ext cx="5373964" cy="2732400"/>
          </a:xfrm>
          <a:prstGeom prst="rect">
            <a:avLst/>
          </a:prstGeom>
          <a:noFill/>
          <a:ln w="1905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B55AB2DF-C105-1CAA-0E22-53EBA048C870}"/>
              </a:ext>
            </a:extLst>
          </p:cNvPr>
          <p:cNvSpPr txBox="1"/>
          <p:nvPr/>
        </p:nvSpPr>
        <p:spPr>
          <a:xfrm>
            <a:off x="7317027" y="2348253"/>
            <a:ext cx="4716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 0.03  0.1 0.3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03F32BD-357D-38D9-67A0-90B679270ECB}"/>
              </a:ext>
            </a:extLst>
          </p:cNvPr>
          <p:cNvSpPr txBox="1"/>
          <p:nvPr/>
        </p:nvSpPr>
        <p:spPr>
          <a:xfrm>
            <a:off x="6985175" y="234825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86C546C-49F4-FF72-BB72-BC633A8623C5}"/>
              </a:ext>
            </a:extLst>
          </p:cNvPr>
          <p:cNvSpPr txBox="1"/>
          <p:nvPr/>
        </p:nvSpPr>
        <p:spPr>
          <a:xfrm>
            <a:off x="6985839" y="2009917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EB484F4-47D1-ADC0-6D36-B9FFC2E5354A}"/>
              </a:ext>
            </a:extLst>
          </p:cNvPr>
          <p:cNvSpPr txBox="1"/>
          <p:nvPr/>
        </p:nvSpPr>
        <p:spPr>
          <a:xfrm>
            <a:off x="7317027" y="2009917"/>
            <a:ext cx="5061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+   +     +   +    +   +     (5 ng/mL) </a:t>
            </a:r>
            <a:endParaRPr kumimoji="1"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6C90494-107E-2E1E-D840-B59E66B55DFD}"/>
              </a:ext>
            </a:extLst>
          </p:cNvPr>
          <p:cNvSpPr txBox="1"/>
          <p:nvPr/>
        </p:nvSpPr>
        <p:spPr>
          <a:xfrm>
            <a:off x="7323616" y="2698310"/>
            <a:ext cx="2262753" cy="540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F3BD805-9892-FC00-EAA1-FB8BFAFF32B2}"/>
              </a:ext>
            </a:extLst>
          </p:cNvPr>
          <p:cNvSpPr txBox="1"/>
          <p:nvPr/>
        </p:nvSpPr>
        <p:spPr>
          <a:xfrm>
            <a:off x="6562468" y="3402863"/>
            <a:ext cx="3632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rgbClr val="FF0000"/>
                </a:solidFill>
              </a:rPr>
              <a:t>This</a:t>
            </a:r>
            <a:r>
              <a:rPr kumimoji="1" lang="zh-CN" altLang="en-US" dirty="0">
                <a:solidFill>
                  <a:srgbClr val="FF0000"/>
                </a:solidFill>
              </a:rPr>
              <a:t> </a:t>
            </a:r>
            <a:r>
              <a:rPr kumimoji="1" lang="en-US" altLang="zh-CN" dirty="0">
                <a:solidFill>
                  <a:srgbClr val="FF0000"/>
                </a:solidFill>
              </a:rPr>
              <a:t>part was shown in manuscript.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2FDCDD3-8636-EC17-CE50-DEFB26675B7B}"/>
              </a:ext>
            </a:extLst>
          </p:cNvPr>
          <p:cNvSpPr txBox="1"/>
          <p:nvPr/>
        </p:nvSpPr>
        <p:spPr>
          <a:xfrm>
            <a:off x="5088379" y="4943960"/>
            <a:ext cx="178125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Fig. 5A</a:t>
            </a:r>
            <a:endParaRPr kumimoji="1" lang="zh-CN" altLang="en-US" sz="40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CA12B07-64E9-0578-B230-958C02F02715}"/>
              </a:ext>
            </a:extLst>
          </p:cNvPr>
          <p:cNvSpPr txBox="1"/>
          <p:nvPr/>
        </p:nvSpPr>
        <p:spPr>
          <a:xfrm>
            <a:off x="2714694" y="1109215"/>
            <a:ext cx="6575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GR</a:t>
            </a:r>
            <a:endParaRPr kumimoji="1" lang="zh-CN" altLang="en-US" sz="28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397C136-9C2D-32F2-8644-F23050BEA4ED}"/>
              </a:ext>
            </a:extLst>
          </p:cNvPr>
          <p:cNvSpPr txBox="1"/>
          <p:nvPr/>
        </p:nvSpPr>
        <p:spPr>
          <a:xfrm>
            <a:off x="8776532" y="1143353"/>
            <a:ext cx="8098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TBP</a:t>
            </a:r>
            <a:endParaRPr kumimoji="1"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9196229-D952-EA66-BCC9-401A95E84AD9}"/>
              </a:ext>
            </a:extLst>
          </p:cNvPr>
          <p:cNvSpPr txBox="1"/>
          <p:nvPr/>
        </p:nvSpPr>
        <p:spPr>
          <a:xfrm>
            <a:off x="3236654" y="5625800"/>
            <a:ext cx="57038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Replicates performed-1</a:t>
            </a:r>
            <a:endParaRPr kumimoji="1"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25101584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图片 23" descr="图片包含 游戏机, 飞机&#10;&#10;描述已自动生成">
            <a:extLst>
              <a:ext uri="{FF2B5EF4-FFF2-40B4-BE49-F238E27FC236}">
                <a16:creationId xmlns:a16="http://schemas.microsoft.com/office/drawing/2014/main" id="{0565D831-E36F-2F80-0AE8-1E908CF708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33932" y="1661517"/>
            <a:ext cx="5015375" cy="3460752"/>
          </a:xfrm>
          <a:prstGeom prst="rect">
            <a:avLst/>
          </a:prstGeom>
        </p:spPr>
      </p:pic>
      <p:pic>
        <p:nvPicPr>
          <p:cNvPr id="13" name="图片 12" descr="图片包含 游戏机&#10;&#10;描述已自动生成">
            <a:extLst>
              <a:ext uri="{FF2B5EF4-FFF2-40B4-BE49-F238E27FC236}">
                <a16:creationId xmlns:a16="http://schemas.microsoft.com/office/drawing/2014/main" id="{501DC15F-D5F6-9613-92FC-A5BA91335D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8953" y="1717038"/>
            <a:ext cx="5185572" cy="3350899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8C82C04-7C8B-1ACC-36F7-4DD091E79644}"/>
              </a:ext>
            </a:extLst>
          </p:cNvPr>
          <p:cNvSpPr txBox="1"/>
          <p:nvPr/>
        </p:nvSpPr>
        <p:spPr>
          <a:xfrm>
            <a:off x="1213284" y="2350833"/>
            <a:ext cx="4653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0.03  0.1 0.3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67DFC13-7A07-AC62-030B-57B4263E5A04}"/>
              </a:ext>
            </a:extLst>
          </p:cNvPr>
          <p:cNvSpPr txBox="1"/>
          <p:nvPr/>
        </p:nvSpPr>
        <p:spPr>
          <a:xfrm>
            <a:off x="881432" y="235083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B531A10-4180-9A30-8DD0-79927A784CB7}"/>
              </a:ext>
            </a:extLst>
          </p:cNvPr>
          <p:cNvSpPr txBox="1"/>
          <p:nvPr/>
        </p:nvSpPr>
        <p:spPr>
          <a:xfrm>
            <a:off x="882096" y="2012497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EBF7D1F-5938-2DCD-99BE-A47C7BE6960A}"/>
              </a:ext>
            </a:extLst>
          </p:cNvPr>
          <p:cNvSpPr txBox="1"/>
          <p:nvPr/>
        </p:nvSpPr>
        <p:spPr>
          <a:xfrm>
            <a:off x="1213284" y="2012497"/>
            <a:ext cx="5061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+   +     +   +    +   +    (5 ng/mL)  </a:t>
            </a:r>
            <a:endParaRPr kumimoji="1"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55AB2DF-C105-1CAA-0E22-53EBA048C870}"/>
              </a:ext>
            </a:extLst>
          </p:cNvPr>
          <p:cNvSpPr txBox="1"/>
          <p:nvPr/>
        </p:nvSpPr>
        <p:spPr>
          <a:xfrm>
            <a:off x="6859826" y="2348253"/>
            <a:ext cx="4716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 0.03  0.1 0.3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03F32BD-357D-38D9-67A0-90B679270ECB}"/>
              </a:ext>
            </a:extLst>
          </p:cNvPr>
          <p:cNvSpPr txBox="1"/>
          <p:nvPr/>
        </p:nvSpPr>
        <p:spPr>
          <a:xfrm>
            <a:off x="6527974" y="234825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86C546C-49F4-FF72-BB72-BC633A8623C5}"/>
              </a:ext>
            </a:extLst>
          </p:cNvPr>
          <p:cNvSpPr txBox="1"/>
          <p:nvPr/>
        </p:nvSpPr>
        <p:spPr>
          <a:xfrm>
            <a:off x="6528638" y="2009917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EB484F4-47D1-ADC0-6D36-B9FFC2E5354A}"/>
              </a:ext>
            </a:extLst>
          </p:cNvPr>
          <p:cNvSpPr txBox="1"/>
          <p:nvPr/>
        </p:nvSpPr>
        <p:spPr>
          <a:xfrm>
            <a:off x="6859826" y="2009917"/>
            <a:ext cx="5123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+   +     +   +    +   +      (5 ng/mL) </a:t>
            </a:r>
            <a:endParaRPr kumimoji="1"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2FDCDD3-8636-EC17-CE50-DEFB26675B7B}"/>
              </a:ext>
            </a:extLst>
          </p:cNvPr>
          <p:cNvSpPr txBox="1"/>
          <p:nvPr/>
        </p:nvSpPr>
        <p:spPr>
          <a:xfrm>
            <a:off x="5088379" y="4943960"/>
            <a:ext cx="178125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Fig. 5A</a:t>
            </a:r>
            <a:endParaRPr kumimoji="1" lang="zh-CN" altLang="en-US" sz="40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CA12B07-64E9-0578-B230-958C02F02715}"/>
              </a:ext>
            </a:extLst>
          </p:cNvPr>
          <p:cNvSpPr txBox="1"/>
          <p:nvPr/>
        </p:nvSpPr>
        <p:spPr>
          <a:xfrm>
            <a:off x="2714694" y="1109215"/>
            <a:ext cx="6575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GR</a:t>
            </a:r>
            <a:endParaRPr kumimoji="1" lang="zh-CN" altLang="en-US" sz="28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397C136-9C2D-32F2-8644-F23050BEA4ED}"/>
              </a:ext>
            </a:extLst>
          </p:cNvPr>
          <p:cNvSpPr txBox="1"/>
          <p:nvPr/>
        </p:nvSpPr>
        <p:spPr>
          <a:xfrm>
            <a:off x="8776532" y="1143353"/>
            <a:ext cx="8098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TBP</a:t>
            </a:r>
            <a:endParaRPr kumimoji="1"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9196229-D952-EA66-BCC9-401A95E84AD9}"/>
              </a:ext>
            </a:extLst>
          </p:cNvPr>
          <p:cNvSpPr txBox="1"/>
          <p:nvPr/>
        </p:nvSpPr>
        <p:spPr>
          <a:xfrm>
            <a:off x="3236654" y="5625800"/>
            <a:ext cx="57038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Replicates performed-2</a:t>
            </a:r>
            <a:endParaRPr kumimoji="1"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33538350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 descr="图片包含 游戏机, 飞机, 男人&#10;&#10;描述已自动生成">
            <a:extLst>
              <a:ext uri="{FF2B5EF4-FFF2-40B4-BE49-F238E27FC236}">
                <a16:creationId xmlns:a16="http://schemas.microsoft.com/office/drawing/2014/main" id="{40AB35D7-C3B2-5C42-CF1D-BCA8A8A7B1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08037" y="1404963"/>
            <a:ext cx="5146826" cy="3378701"/>
          </a:xfrm>
          <a:prstGeom prst="rect">
            <a:avLst/>
          </a:prstGeom>
        </p:spPr>
      </p:pic>
      <p:pic>
        <p:nvPicPr>
          <p:cNvPr id="4" name="图片 3" descr="图片包含 形状&#10;&#10;描述已自动生成">
            <a:extLst>
              <a:ext uri="{FF2B5EF4-FFF2-40B4-BE49-F238E27FC236}">
                <a16:creationId xmlns:a16="http://schemas.microsoft.com/office/drawing/2014/main" id="{FD13EB1D-9CE8-F983-37BF-B7047644D5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6592" y="1370825"/>
            <a:ext cx="4960124" cy="3412839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8C82C04-7C8B-1ACC-36F7-4DD091E79644}"/>
              </a:ext>
            </a:extLst>
          </p:cNvPr>
          <p:cNvSpPr txBox="1"/>
          <p:nvPr/>
        </p:nvSpPr>
        <p:spPr>
          <a:xfrm>
            <a:off x="1213284" y="2350833"/>
            <a:ext cx="4653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0.03  0.1 0.3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67DFC13-7A07-AC62-030B-57B4263E5A04}"/>
              </a:ext>
            </a:extLst>
          </p:cNvPr>
          <p:cNvSpPr txBox="1"/>
          <p:nvPr/>
        </p:nvSpPr>
        <p:spPr>
          <a:xfrm>
            <a:off x="881432" y="235083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B531A10-4180-9A30-8DD0-79927A784CB7}"/>
              </a:ext>
            </a:extLst>
          </p:cNvPr>
          <p:cNvSpPr txBox="1"/>
          <p:nvPr/>
        </p:nvSpPr>
        <p:spPr>
          <a:xfrm>
            <a:off x="882096" y="2012497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EBF7D1F-5938-2DCD-99BE-A47C7BE6960A}"/>
              </a:ext>
            </a:extLst>
          </p:cNvPr>
          <p:cNvSpPr txBox="1"/>
          <p:nvPr/>
        </p:nvSpPr>
        <p:spPr>
          <a:xfrm>
            <a:off x="1213284" y="2012497"/>
            <a:ext cx="5061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+   +     +   +    +   +     (5 ng/mL) </a:t>
            </a:r>
            <a:endParaRPr kumimoji="1"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55AB2DF-C105-1CAA-0E22-53EBA048C870}"/>
              </a:ext>
            </a:extLst>
          </p:cNvPr>
          <p:cNvSpPr txBox="1"/>
          <p:nvPr/>
        </p:nvSpPr>
        <p:spPr>
          <a:xfrm>
            <a:off x="7317027" y="2348253"/>
            <a:ext cx="4716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 0.03  0.1 0.3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03F32BD-357D-38D9-67A0-90B679270ECB}"/>
              </a:ext>
            </a:extLst>
          </p:cNvPr>
          <p:cNvSpPr txBox="1"/>
          <p:nvPr/>
        </p:nvSpPr>
        <p:spPr>
          <a:xfrm>
            <a:off x="6985175" y="234825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86C546C-49F4-FF72-BB72-BC633A8623C5}"/>
              </a:ext>
            </a:extLst>
          </p:cNvPr>
          <p:cNvSpPr txBox="1"/>
          <p:nvPr/>
        </p:nvSpPr>
        <p:spPr>
          <a:xfrm>
            <a:off x="6985839" y="2009917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EB484F4-47D1-ADC0-6D36-B9FFC2E5354A}"/>
              </a:ext>
            </a:extLst>
          </p:cNvPr>
          <p:cNvSpPr txBox="1"/>
          <p:nvPr/>
        </p:nvSpPr>
        <p:spPr>
          <a:xfrm>
            <a:off x="7317027" y="2009917"/>
            <a:ext cx="5061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+   +     +   +    +   +     (5 ng/mL) </a:t>
            </a:r>
            <a:endParaRPr kumimoji="1"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2FDCDD3-8636-EC17-CE50-DEFB26675B7B}"/>
              </a:ext>
            </a:extLst>
          </p:cNvPr>
          <p:cNvSpPr txBox="1"/>
          <p:nvPr/>
        </p:nvSpPr>
        <p:spPr>
          <a:xfrm>
            <a:off x="5088379" y="4943960"/>
            <a:ext cx="178125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Fig. 5A</a:t>
            </a:r>
            <a:endParaRPr kumimoji="1" lang="zh-CN" altLang="en-US" sz="40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CA12B07-64E9-0578-B230-958C02F02715}"/>
              </a:ext>
            </a:extLst>
          </p:cNvPr>
          <p:cNvSpPr txBox="1"/>
          <p:nvPr/>
        </p:nvSpPr>
        <p:spPr>
          <a:xfrm>
            <a:off x="2714694" y="839050"/>
            <a:ext cx="6575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GR</a:t>
            </a:r>
            <a:endParaRPr kumimoji="1" lang="zh-CN" altLang="en-US" sz="28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397C136-9C2D-32F2-8644-F23050BEA4ED}"/>
              </a:ext>
            </a:extLst>
          </p:cNvPr>
          <p:cNvSpPr txBox="1"/>
          <p:nvPr/>
        </p:nvSpPr>
        <p:spPr>
          <a:xfrm>
            <a:off x="8776532" y="852407"/>
            <a:ext cx="8098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TBP</a:t>
            </a:r>
            <a:endParaRPr kumimoji="1"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9196229-D952-EA66-BCC9-401A95E84AD9}"/>
              </a:ext>
            </a:extLst>
          </p:cNvPr>
          <p:cNvSpPr txBox="1"/>
          <p:nvPr/>
        </p:nvSpPr>
        <p:spPr>
          <a:xfrm>
            <a:off x="3236654" y="5625800"/>
            <a:ext cx="57038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Replicates performed-3</a:t>
            </a:r>
            <a:endParaRPr kumimoji="1"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16943760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 descr="图片包含 游戏机&#10;&#10;描述已自动生成">
            <a:extLst>
              <a:ext uri="{FF2B5EF4-FFF2-40B4-BE49-F238E27FC236}">
                <a16:creationId xmlns:a16="http://schemas.microsoft.com/office/drawing/2014/main" id="{70DD7858-A90B-47F6-8CFA-BAE18A156E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12024" y="1775964"/>
            <a:ext cx="4903680" cy="3073591"/>
          </a:xfrm>
          <a:prstGeom prst="rect">
            <a:avLst/>
          </a:prstGeom>
        </p:spPr>
      </p:pic>
      <p:pic>
        <p:nvPicPr>
          <p:cNvPr id="11" name="图片 10" descr="在地上&#10;&#10;中度可信度描述已自动生成">
            <a:extLst>
              <a:ext uri="{FF2B5EF4-FFF2-40B4-BE49-F238E27FC236}">
                <a16:creationId xmlns:a16="http://schemas.microsoft.com/office/drawing/2014/main" id="{725D2E5F-DA6D-FE48-04B2-E6E58DB6AEB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6296" y="1666573"/>
            <a:ext cx="5276989" cy="3182983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8C82C04-7C8B-1ACC-36F7-4DD091E79644}"/>
              </a:ext>
            </a:extLst>
          </p:cNvPr>
          <p:cNvSpPr txBox="1"/>
          <p:nvPr/>
        </p:nvSpPr>
        <p:spPr>
          <a:xfrm>
            <a:off x="1213284" y="2350833"/>
            <a:ext cx="4653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0.03  0.1 0.3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67DFC13-7A07-AC62-030B-57B4263E5A04}"/>
              </a:ext>
            </a:extLst>
          </p:cNvPr>
          <p:cNvSpPr txBox="1"/>
          <p:nvPr/>
        </p:nvSpPr>
        <p:spPr>
          <a:xfrm>
            <a:off x="881432" y="235083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B531A10-4180-9A30-8DD0-79927A784CB7}"/>
              </a:ext>
            </a:extLst>
          </p:cNvPr>
          <p:cNvSpPr txBox="1"/>
          <p:nvPr/>
        </p:nvSpPr>
        <p:spPr>
          <a:xfrm>
            <a:off x="882096" y="2012497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EBF7D1F-5938-2DCD-99BE-A47C7BE6960A}"/>
              </a:ext>
            </a:extLst>
          </p:cNvPr>
          <p:cNvSpPr txBox="1"/>
          <p:nvPr/>
        </p:nvSpPr>
        <p:spPr>
          <a:xfrm>
            <a:off x="1213284" y="2012497"/>
            <a:ext cx="5061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+   +     +   +    +   +     (5 ng/mL) </a:t>
            </a:r>
            <a:endParaRPr kumimoji="1"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55AB2DF-C105-1CAA-0E22-53EBA048C870}"/>
              </a:ext>
            </a:extLst>
          </p:cNvPr>
          <p:cNvSpPr txBox="1"/>
          <p:nvPr/>
        </p:nvSpPr>
        <p:spPr>
          <a:xfrm>
            <a:off x="7379373" y="2639201"/>
            <a:ext cx="4716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 0.03  0.1 0.3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03F32BD-357D-38D9-67A0-90B679270ECB}"/>
              </a:ext>
            </a:extLst>
          </p:cNvPr>
          <p:cNvSpPr txBox="1"/>
          <p:nvPr/>
        </p:nvSpPr>
        <p:spPr>
          <a:xfrm>
            <a:off x="7047521" y="2639201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86C546C-49F4-FF72-BB72-BC633A8623C5}"/>
              </a:ext>
            </a:extLst>
          </p:cNvPr>
          <p:cNvSpPr txBox="1"/>
          <p:nvPr/>
        </p:nvSpPr>
        <p:spPr>
          <a:xfrm>
            <a:off x="7048185" y="2300865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EB484F4-47D1-ADC0-6D36-B9FFC2E5354A}"/>
              </a:ext>
            </a:extLst>
          </p:cNvPr>
          <p:cNvSpPr txBox="1"/>
          <p:nvPr/>
        </p:nvSpPr>
        <p:spPr>
          <a:xfrm>
            <a:off x="7379373" y="2300865"/>
            <a:ext cx="4998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+   +     +   +    +   +    (5 ng/mL) </a:t>
            </a:r>
            <a:endParaRPr kumimoji="1"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2FDCDD3-8636-EC17-CE50-DEFB26675B7B}"/>
              </a:ext>
            </a:extLst>
          </p:cNvPr>
          <p:cNvSpPr txBox="1"/>
          <p:nvPr/>
        </p:nvSpPr>
        <p:spPr>
          <a:xfrm>
            <a:off x="5088379" y="4943960"/>
            <a:ext cx="178125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Fig. 5A</a:t>
            </a:r>
            <a:endParaRPr kumimoji="1" lang="zh-CN" altLang="en-US" sz="40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CA12B07-64E9-0578-B230-958C02F02715}"/>
              </a:ext>
            </a:extLst>
          </p:cNvPr>
          <p:cNvSpPr txBox="1"/>
          <p:nvPr/>
        </p:nvSpPr>
        <p:spPr>
          <a:xfrm>
            <a:off x="2714694" y="1109215"/>
            <a:ext cx="6575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GR</a:t>
            </a:r>
            <a:endParaRPr kumimoji="1" lang="zh-CN" altLang="en-US" sz="28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397C136-9C2D-32F2-8644-F23050BEA4ED}"/>
              </a:ext>
            </a:extLst>
          </p:cNvPr>
          <p:cNvSpPr txBox="1"/>
          <p:nvPr/>
        </p:nvSpPr>
        <p:spPr>
          <a:xfrm>
            <a:off x="8776532" y="1143353"/>
            <a:ext cx="8098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TBP</a:t>
            </a:r>
            <a:endParaRPr kumimoji="1"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9196229-D952-EA66-BCC9-401A95E84AD9}"/>
              </a:ext>
            </a:extLst>
          </p:cNvPr>
          <p:cNvSpPr txBox="1"/>
          <p:nvPr/>
        </p:nvSpPr>
        <p:spPr>
          <a:xfrm>
            <a:off x="3236654" y="5625800"/>
            <a:ext cx="57038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Replicates performed-4</a:t>
            </a:r>
            <a:endParaRPr kumimoji="1"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384880884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4" name="Picture 13" descr="C:\Users\Xu WenCheng\Desktop\图片1.tif">
            <a:extLst>
              <a:ext uri="{FF2B5EF4-FFF2-40B4-BE49-F238E27FC236}">
                <a16:creationId xmlns:a16="http://schemas.microsoft.com/office/drawing/2014/main" id="{5D1A2E63-3DCB-9824-E424-C2E391DB11D1}"/>
              </a:ext>
            </a:extLst>
          </p:cNvPr>
          <p:cNvPicPr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1" t="11059" r="5733" b="8714"/>
          <a:stretch/>
        </p:blipFill>
        <p:spPr bwMode="auto">
          <a:xfrm>
            <a:off x="619933" y="1747434"/>
            <a:ext cx="5191932" cy="33631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F399D7FC-D591-3DCA-4DF0-01A86FBE2118}"/>
              </a:ext>
            </a:extLst>
          </p:cNvPr>
          <p:cNvSpPr txBox="1"/>
          <p:nvPr/>
        </p:nvSpPr>
        <p:spPr>
          <a:xfrm>
            <a:off x="1197786" y="2939768"/>
            <a:ext cx="47788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  0.03 0.1 0.3 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CBF7F53-E0EE-C3A8-78B9-545F5C4723E1}"/>
              </a:ext>
            </a:extLst>
          </p:cNvPr>
          <p:cNvSpPr txBox="1"/>
          <p:nvPr/>
        </p:nvSpPr>
        <p:spPr>
          <a:xfrm>
            <a:off x="865934" y="293976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37749A1-C82A-75A8-3536-95D5EB468246}"/>
              </a:ext>
            </a:extLst>
          </p:cNvPr>
          <p:cNvSpPr txBox="1"/>
          <p:nvPr/>
        </p:nvSpPr>
        <p:spPr>
          <a:xfrm>
            <a:off x="866598" y="2601432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B6B65D8-3BA9-2E3A-8772-D212317470F3}"/>
              </a:ext>
            </a:extLst>
          </p:cNvPr>
          <p:cNvSpPr txBox="1"/>
          <p:nvPr/>
        </p:nvSpPr>
        <p:spPr>
          <a:xfrm>
            <a:off x="1197786" y="2601432"/>
            <a:ext cx="52485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 +   +     +    +    +   +     (5 ng/mL)  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7247610-9A4C-6F95-5143-C251144CD01E}"/>
              </a:ext>
            </a:extLst>
          </p:cNvPr>
          <p:cNvSpPr txBox="1"/>
          <p:nvPr/>
        </p:nvSpPr>
        <p:spPr>
          <a:xfrm>
            <a:off x="1246421" y="3243211"/>
            <a:ext cx="2262753" cy="540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5F2AB3B-B578-7905-4F82-5631EBBD4D54}"/>
              </a:ext>
            </a:extLst>
          </p:cNvPr>
          <p:cNvSpPr txBox="1"/>
          <p:nvPr/>
        </p:nvSpPr>
        <p:spPr>
          <a:xfrm>
            <a:off x="1201837" y="3979253"/>
            <a:ext cx="3632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rgbClr val="FF0000"/>
                </a:solidFill>
              </a:rPr>
              <a:t>This</a:t>
            </a:r>
            <a:r>
              <a:rPr kumimoji="1" lang="zh-CN" altLang="en-US" dirty="0">
                <a:solidFill>
                  <a:srgbClr val="FF0000"/>
                </a:solidFill>
              </a:rPr>
              <a:t> </a:t>
            </a:r>
            <a:r>
              <a:rPr kumimoji="1" lang="en-US" altLang="zh-CN" dirty="0">
                <a:solidFill>
                  <a:srgbClr val="FF0000"/>
                </a:solidFill>
              </a:rPr>
              <a:t>part was shown in manuscript.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79F62E7-8E07-A224-B675-0FFDE79D1153}"/>
              </a:ext>
            </a:extLst>
          </p:cNvPr>
          <p:cNvSpPr txBox="1"/>
          <p:nvPr/>
        </p:nvSpPr>
        <p:spPr>
          <a:xfrm>
            <a:off x="5103662" y="5244308"/>
            <a:ext cx="174599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Fig. 5B</a:t>
            </a:r>
            <a:endParaRPr kumimoji="1" lang="zh-CN" altLang="en-US" sz="40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CD8C9D2-A298-AE35-5FD6-182BD920AD66}"/>
              </a:ext>
            </a:extLst>
          </p:cNvPr>
          <p:cNvSpPr txBox="1"/>
          <p:nvPr/>
        </p:nvSpPr>
        <p:spPr>
          <a:xfrm>
            <a:off x="2714694" y="1109215"/>
            <a:ext cx="6575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GR</a:t>
            </a:r>
            <a:endParaRPr kumimoji="1" lang="zh-CN" altLang="en-US" sz="2800" b="1" dirty="0"/>
          </a:p>
        </p:txBody>
      </p:sp>
      <p:pic>
        <p:nvPicPr>
          <p:cNvPr id="14" name="Picture 9" descr="E:\WB\20200109\20200109_7b 4s prime.TIFF">
            <a:extLst>
              <a:ext uri="{FF2B5EF4-FFF2-40B4-BE49-F238E27FC236}">
                <a16:creationId xmlns:a16="http://schemas.microsoft.com/office/drawing/2014/main" id="{4D3B2D6F-DF2B-43F4-F05B-57A7A1155DBF}"/>
              </a:ext>
            </a:extLst>
          </p:cNvPr>
          <p:cNvPicPr>
            <a:picLocks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7" t="6405" r="742" b="538"/>
          <a:stretch/>
        </p:blipFill>
        <p:spPr bwMode="auto">
          <a:xfrm>
            <a:off x="6262569" y="1747433"/>
            <a:ext cx="5578136" cy="3363131"/>
          </a:xfrm>
          <a:prstGeom prst="rect">
            <a:avLst/>
          </a:prstGeom>
          <a:noFill/>
          <a:ln w="1905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458FB3FA-B76C-1AFC-460B-6123BFEF1ECC}"/>
              </a:ext>
            </a:extLst>
          </p:cNvPr>
          <p:cNvSpPr txBox="1"/>
          <p:nvPr/>
        </p:nvSpPr>
        <p:spPr>
          <a:xfrm>
            <a:off x="6991568" y="2348251"/>
            <a:ext cx="4841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0     0   0.03 0.1  0.3    0  0.03 0.1 0.3    (</a:t>
            </a:r>
            <a:r>
              <a:rPr kumimoji="1" lang="en-US" altLang="zh-CN" dirty="0" err="1"/>
              <a:t>μM</a:t>
            </a:r>
            <a:r>
              <a:rPr kumimoji="1" lang="en-US" altLang="zh-CN" dirty="0"/>
              <a:t>)  </a:t>
            </a:r>
            <a:endParaRPr kumimoji="1"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70979E3-C2AD-D809-1039-03D1686BAA0E}"/>
              </a:ext>
            </a:extLst>
          </p:cNvPr>
          <p:cNvSpPr txBox="1"/>
          <p:nvPr/>
        </p:nvSpPr>
        <p:spPr>
          <a:xfrm>
            <a:off x="6659716" y="2348251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CEP</a:t>
            </a:r>
            <a:endParaRPr kumimoji="1"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9A0A83C-5525-728D-3A0E-D611DEE64AB9}"/>
              </a:ext>
            </a:extLst>
          </p:cNvPr>
          <p:cNvSpPr txBox="1"/>
          <p:nvPr/>
        </p:nvSpPr>
        <p:spPr>
          <a:xfrm>
            <a:off x="6660380" y="2009915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P</a:t>
            </a:r>
            <a:endParaRPr kumimoji="1"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A6CB0C5-A9BF-0BD9-3D30-812D58598980}"/>
              </a:ext>
            </a:extLst>
          </p:cNvPr>
          <p:cNvSpPr txBox="1"/>
          <p:nvPr/>
        </p:nvSpPr>
        <p:spPr>
          <a:xfrm>
            <a:off x="6991568" y="2009915"/>
            <a:ext cx="5237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    -     +    +     +    +     +    +    +   +     (5 ng/mL) </a:t>
            </a:r>
            <a:endParaRPr kumimoji="1"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A7B78DF-1055-94F8-92E7-1008570E5CFB}"/>
              </a:ext>
            </a:extLst>
          </p:cNvPr>
          <p:cNvSpPr txBox="1"/>
          <p:nvPr/>
        </p:nvSpPr>
        <p:spPr>
          <a:xfrm>
            <a:off x="7102196" y="2667188"/>
            <a:ext cx="2262753" cy="540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7098613-C8D9-CEFE-16B4-CF97877A0AD1}"/>
              </a:ext>
            </a:extLst>
          </p:cNvPr>
          <p:cNvSpPr txBox="1"/>
          <p:nvPr/>
        </p:nvSpPr>
        <p:spPr>
          <a:xfrm>
            <a:off x="7057612" y="3310242"/>
            <a:ext cx="3632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solidFill>
                  <a:srgbClr val="FF0000"/>
                </a:solidFill>
              </a:rPr>
              <a:t>This</a:t>
            </a:r>
            <a:r>
              <a:rPr kumimoji="1" lang="zh-CN" altLang="en-US" dirty="0">
                <a:solidFill>
                  <a:srgbClr val="FF0000"/>
                </a:solidFill>
              </a:rPr>
              <a:t> </a:t>
            </a:r>
            <a:r>
              <a:rPr kumimoji="1" lang="en-US" altLang="zh-CN" dirty="0">
                <a:solidFill>
                  <a:srgbClr val="FF0000"/>
                </a:solidFill>
              </a:rPr>
              <a:t>part was shown in manuscript.</a:t>
            </a:r>
            <a:endParaRPr kumimoji="1" lang="zh-CN" altLang="en-US" dirty="0">
              <a:solidFill>
                <a:srgbClr val="FF0000"/>
              </a:solidFill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F8BFCC0-CFEA-A5C9-E7C3-AB29DD3FBA44}"/>
              </a:ext>
            </a:extLst>
          </p:cNvPr>
          <p:cNvSpPr txBox="1"/>
          <p:nvPr/>
        </p:nvSpPr>
        <p:spPr>
          <a:xfrm>
            <a:off x="8370200" y="1081115"/>
            <a:ext cx="13628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2800" b="1" dirty="0"/>
              <a:t>β</a:t>
            </a:r>
            <a:r>
              <a:rPr kumimoji="1" lang="en-US" altLang="zh-CN" sz="2800" b="1" dirty="0"/>
              <a:t>-actin</a:t>
            </a:r>
            <a:endParaRPr kumimoji="1"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D85FBBE-C5F1-CDD8-AB85-3BBED778DD1C}"/>
              </a:ext>
            </a:extLst>
          </p:cNvPr>
          <p:cNvSpPr txBox="1"/>
          <p:nvPr/>
        </p:nvSpPr>
        <p:spPr>
          <a:xfrm>
            <a:off x="3170169" y="5847698"/>
            <a:ext cx="57038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0" b="1" dirty="0"/>
              <a:t>Replicates performed-1</a:t>
            </a:r>
            <a:endParaRPr kumimoji="1"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4126160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746</Words>
  <Application>Microsoft Office PowerPoint</Application>
  <PresentationFormat>宽屏</PresentationFormat>
  <Paragraphs>138</Paragraphs>
  <Slides>1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ve8007</dc:creator>
  <cp:lastModifiedBy>Admin</cp:lastModifiedBy>
  <cp:revision>3</cp:revision>
  <dcterms:created xsi:type="dcterms:W3CDTF">2024-03-22T15:28:45Z</dcterms:created>
  <dcterms:modified xsi:type="dcterms:W3CDTF">2024-03-26T20:53:55Z</dcterms:modified>
</cp:coreProperties>
</file>